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3C356-6496-42C0-9FCB-413B888316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9BFCB-85E8-4BB4-86D9-E2F31463A0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B857F-A298-4E71-A781-03A7E06C03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DE378-4B63-43E3-AF22-178E4339E9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10394-8B59-42EE-9EE7-3201055BE0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5B62B-D413-4A81-8538-3BBF9745AA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7AE83-D0FF-4897-BAE4-4E9F236271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26746-1B29-4B6E-9179-212EC11857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71105-2147-4D3E-B803-EEF82EE5BD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7AB7A-6861-4551-8E23-97C996917B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15A45-8399-45A0-976F-F09A83F43E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0A8C2-FEAC-4D3C-AD5F-080CD03635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443A68-AB3D-43C3-B56F-3F365A5DAC5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86040" y="24462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5551" t="15276" r="4724" b="41680"/>
          <a:stretch/>
        </p:blipFill>
        <p:spPr>
          <a:xfrm>
            <a:off x="0" y="990720"/>
            <a:ext cx="9128160" cy="32763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533520" y="4800600"/>
            <a:ext cx="81691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3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ylogenetic analyses of the LRR domain of all the proteins showing high similarity (Expect &lt;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with at least one of the six LGR protein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 amoebophi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Minimum Evolution comparing the corrected p-distance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Maximum Parsimony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trees drawn on the amino acids sequences. Bootstrap of 100 samples (in percentage). LRR domains of Toll and Toll-like proteins exhibited not enough similarity with LRR domains of LGRs to be included in these analyses.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19:52Z</dcterms:created>
  <dc:creator>Gilbert Greub</dc:creator>
  <dc:description/>
  <dc:language>en-US</dc:language>
  <cp:lastModifiedBy>Gilbert Greub</cp:lastModifiedBy>
  <dcterms:modified xsi:type="dcterms:W3CDTF">2007-11-11T16:36:58Z</dcterms:modified>
  <cp:revision>5</cp:revision>
  <dc:subject/>
  <dc:title>Présentation PowerPoint</dc:title>
</cp:coreProperties>
</file>